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63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  <a:srgbClr val="E7EAED"/>
    <a:srgbClr val="CCD2D8"/>
    <a:srgbClr val="156082"/>
    <a:srgbClr val="BAD9E4"/>
    <a:srgbClr val="94C3D4"/>
    <a:srgbClr val="1D85B3"/>
    <a:srgbClr val="DEDE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45" d="100"/>
          <a:sy n="45" d="100"/>
        </p:scale>
        <p:origin x="87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jafi, Allison" userId="0304a55d-1748-4b32-895c-375cbdec2d3f" providerId="ADAL" clId="{7D74AE06-39FC-4021-ABED-803528E22EF0}"/>
    <pc:docChg chg="delSld modSld">
      <pc:chgData name="Najafi, Allison" userId="0304a55d-1748-4b32-895c-375cbdec2d3f" providerId="ADAL" clId="{7D74AE06-39FC-4021-ABED-803528E22EF0}" dt="2025-02-12T22:43:55.212" v="9" actId="2165"/>
      <pc:docMkLst>
        <pc:docMk/>
      </pc:docMkLst>
      <pc:sldChg chg="del">
        <pc:chgData name="Najafi, Allison" userId="0304a55d-1748-4b32-895c-375cbdec2d3f" providerId="ADAL" clId="{7D74AE06-39FC-4021-ABED-803528E22EF0}" dt="2025-01-27T21:35:03.362" v="0" actId="47"/>
        <pc:sldMkLst>
          <pc:docMk/>
          <pc:sldMk cId="2725620228" sldId="256"/>
        </pc:sldMkLst>
      </pc:sldChg>
      <pc:sldChg chg="del">
        <pc:chgData name="Najafi, Allison" userId="0304a55d-1748-4b32-895c-375cbdec2d3f" providerId="ADAL" clId="{7D74AE06-39FC-4021-ABED-803528E22EF0}" dt="2025-01-27T21:35:03.714" v="1" actId="47"/>
        <pc:sldMkLst>
          <pc:docMk/>
          <pc:sldMk cId="3569514842" sldId="257"/>
        </pc:sldMkLst>
      </pc:sldChg>
      <pc:sldChg chg="del">
        <pc:chgData name="Najafi, Allison" userId="0304a55d-1748-4b32-895c-375cbdec2d3f" providerId="ADAL" clId="{7D74AE06-39FC-4021-ABED-803528E22EF0}" dt="2025-01-27T21:35:04.462" v="3" actId="47"/>
        <pc:sldMkLst>
          <pc:docMk/>
          <pc:sldMk cId="2505032853" sldId="258"/>
        </pc:sldMkLst>
      </pc:sldChg>
      <pc:sldChg chg="del">
        <pc:chgData name="Najafi, Allison" userId="0304a55d-1748-4b32-895c-375cbdec2d3f" providerId="ADAL" clId="{7D74AE06-39FC-4021-ABED-803528E22EF0}" dt="2025-01-27T21:35:08.246" v="6" actId="47"/>
        <pc:sldMkLst>
          <pc:docMk/>
          <pc:sldMk cId="2305346892" sldId="259"/>
        </pc:sldMkLst>
      </pc:sldChg>
      <pc:sldChg chg="del">
        <pc:chgData name="Najafi, Allison" userId="0304a55d-1748-4b32-895c-375cbdec2d3f" providerId="ADAL" clId="{7D74AE06-39FC-4021-ABED-803528E22EF0}" dt="2025-01-27T21:35:04.068" v="2" actId="47"/>
        <pc:sldMkLst>
          <pc:docMk/>
          <pc:sldMk cId="2192517872" sldId="260"/>
        </pc:sldMkLst>
      </pc:sldChg>
      <pc:sldChg chg="del">
        <pc:chgData name="Najafi, Allison" userId="0304a55d-1748-4b32-895c-375cbdec2d3f" providerId="ADAL" clId="{7D74AE06-39FC-4021-ABED-803528E22EF0}" dt="2025-01-27T21:35:06.234" v="5" actId="47"/>
        <pc:sldMkLst>
          <pc:docMk/>
          <pc:sldMk cId="3507118384" sldId="262"/>
        </pc:sldMkLst>
      </pc:sldChg>
      <pc:sldChg chg="modSp mod">
        <pc:chgData name="Najafi, Allison" userId="0304a55d-1748-4b32-895c-375cbdec2d3f" providerId="ADAL" clId="{7D74AE06-39FC-4021-ABED-803528E22EF0}" dt="2025-02-12T22:43:55.212" v="9" actId="2165"/>
        <pc:sldMkLst>
          <pc:docMk/>
          <pc:sldMk cId="3515496556" sldId="263"/>
        </pc:sldMkLst>
        <pc:graphicFrameChg chg="modGraphic">
          <ac:chgData name="Najafi, Allison" userId="0304a55d-1748-4b32-895c-375cbdec2d3f" providerId="ADAL" clId="{7D74AE06-39FC-4021-ABED-803528E22EF0}" dt="2025-02-12T22:43:55.212" v="9" actId="2165"/>
          <ac:graphicFrameMkLst>
            <pc:docMk/>
            <pc:sldMk cId="3515496556" sldId="263"/>
            <ac:graphicFrameMk id="4" creationId="{D66E9472-E268-9733-D867-777CD44255B1}"/>
          </ac:graphicFrameMkLst>
        </pc:graphicFrameChg>
      </pc:sldChg>
      <pc:sldChg chg="del">
        <pc:chgData name="Najafi, Allison" userId="0304a55d-1748-4b32-895c-375cbdec2d3f" providerId="ADAL" clId="{7D74AE06-39FC-4021-ABED-803528E22EF0}" dt="2025-01-27T21:35:08.528" v="7" actId="47"/>
        <pc:sldMkLst>
          <pc:docMk/>
          <pc:sldMk cId="2264077816" sldId="264"/>
        </pc:sldMkLst>
      </pc:sldChg>
      <pc:sldChg chg="del">
        <pc:chgData name="Najafi, Allison" userId="0304a55d-1748-4b32-895c-375cbdec2d3f" providerId="ADAL" clId="{7D74AE06-39FC-4021-ABED-803528E22EF0}" dt="2025-01-27T21:35:09.104" v="8" actId="47"/>
        <pc:sldMkLst>
          <pc:docMk/>
          <pc:sldMk cId="639073537" sldId="265"/>
        </pc:sldMkLst>
      </pc:sldChg>
      <pc:sldChg chg="del">
        <pc:chgData name="Najafi, Allison" userId="0304a55d-1748-4b32-895c-375cbdec2d3f" providerId="ADAL" clId="{7D74AE06-39FC-4021-ABED-803528E22EF0}" dt="2025-01-27T21:35:05.024" v="4" actId="47"/>
        <pc:sldMkLst>
          <pc:docMk/>
          <pc:sldMk cId="1558034745" sldId="26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04D3A9-35B5-48F4-9529-65B199B619BB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1A9764-E4BA-4EB9-9AD5-E4A142AF89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234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6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962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373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7760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326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202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3680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276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553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391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730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0E17E5-8E71-45BA-9800-8123D4E470C7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8F49D8-F32A-41AF-93FB-BAA1FF8EB1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361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66E9472-E268-9733-D867-777CD44255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35504961"/>
              </p:ext>
            </p:extLst>
          </p:nvPr>
        </p:nvGraphicFramePr>
        <p:xfrm>
          <a:off x="1" y="409047"/>
          <a:ext cx="5650992" cy="554657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695858">
                  <a:extLst>
                    <a:ext uri="{9D8B030D-6E8A-4147-A177-3AD203B41FA5}">
                      <a16:colId xmlns:a16="http://schemas.microsoft.com/office/drawing/2014/main" val="1293953461"/>
                    </a:ext>
                  </a:extLst>
                </a:gridCol>
                <a:gridCol w="1129326">
                  <a:extLst>
                    <a:ext uri="{9D8B030D-6E8A-4147-A177-3AD203B41FA5}">
                      <a16:colId xmlns:a16="http://schemas.microsoft.com/office/drawing/2014/main" val="3013028941"/>
                    </a:ext>
                  </a:extLst>
                </a:gridCol>
                <a:gridCol w="1412904">
                  <a:extLst>
                    <a:ext uri="{9D8B030D-6E8A-4147-A177-3AD203B41FA5}">
                      <a16:colId xmlns:a16="http://schemas.microsoft.com/office/drawing/2014/main" val="1258302679"/>
                    </a:ext>
                  </a:extLst>
                </a:gridCol>
                <a:gridCol w="1412904">
                  <a:extLst>
                    <a:ext uri="{9D8B030D-6E8A-4147-A177-3AD203B41FA5}">
                      <a16:colId xmlns:a16="http://schemas.microsoft.com/office/drawing/2014/main" val="4003382788"/>
                    </a:ext>
                  </a:extLst>
                </a:gridCol>
              </a:tblGrid>
              <a:tr h="26512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TURP</a:t>
                      </a:r>
                      <a:endParaRPr lang="en-US" sz="11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PVP</a:t>
                      </a:r>
                      <a:endParaRPr lang="en-US" sz="11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5608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PUL</a:t>
                      </a:r>
                      <a:endParaRPr lang="en-US" sz="11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5608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4220524"/>
                  </a:ext>
                </a:extLst>
              </a:tr>
              <a:tr h="26512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Perioperative Use Only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22834497"/>
                  </a:ext>
                </a:extLst>
              </a:tr>
              <a:tr h="150607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4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055243"/>
                  </a:ext>
                </a:extLst>
              </a:tr>
              <a:tr h="250398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-year 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15608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67229369"/>
                  </a:ext>
                </a:extLst>
              </a:tr>
              <a:tr h="51380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Continued use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(med history prior to procedure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55096841"/>
                  </a:ext>
                </a:extLst>
              </a:tr>
              <a:tr h="150607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4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5722714"/>
                  </a:ext>
                </a:extLst>
              </a:tr>
              <a:tr h="34043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De novo use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(no med history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0997644"/>
                  </a:ext>
                </a:extLst>
              </a:tr>
              <a:tr h="150607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6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93242852"/>
                  </a:ext>
                </a:extLst>
              </a:tr>
              <a:tr h="26512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Total rat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25175140"/>
                  </a:ext>
                </a:extLst>
              </a:tr>
              <a:tr h="150607"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4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4112977"/>
                  </a:ext>
                </a:extLst>
              </a:tr>
              <a:tr h="250398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-year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8325015"/>
                  </a:ext>
                </a:extLst>
              </a:tr>
              <a:tr h="51380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Continued use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(med history prior to procedure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1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1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3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41982695"/>
                  </a:ext>
                </a:extLst>
              </a:tr>
              <a:tr h="150607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4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.0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6694284"/>
                  </a:ext>
                </a:extLst>
              </a:tr>
              <a:tr h="34043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De novo use </a:t>
                      </a:r>
                    </a:p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(no med history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0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CCD2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8674606"/>
                  </a:ext>
                </a:extLst>
              </a:tr>
              <a:tr h="150607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5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05737461"/>
                  </a:ext>
                </a:extLst>
              </a:tr>
              <a:tr h="25039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Total rat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1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1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3%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09232727"/>
                  </a:ext>
                </a:extLst>
              </a:tr>
              <a:tr h="150607">
                <a:tc>
                  <a:txBody>
                    <a:bodyPr/>
                    <a:lstStyle/>
                    <a:p>
                      <a:pPr marL="0" marR="0" lvl="0" indent="0" algn="r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white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% of total meds utilized after surgery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i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6%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7EA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814681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154965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9037ea0-f10b-40ae-9076-89db66a894de">
      <Terms xmlns="http://schemas.microsoft.com/office/infopath/2007/PartnerControls"/>
    </lcf76f155ced4ddcb4097134ff3c332f>
    <TaxCatchAll xmlns="08c674ba-5fce-4f45-b52a-53002431429b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75E9A582350B14998924DDC17E51716" ma:contentTypeVersion="18" ma:contentTypeDescription="Create a new document." ma:contentTypeScope="" ma:versionID="96056b74b4a12ad6a139844a6ffbd153">
  <xsd:schema xmlns:xsd="http://www.w3.org/2001/XMLSchema" xmlns:xs="http://www.w3.org/2001/XMLSchema" xmlns:p="http://schemas.microsoft.com/office/2006/metadata/properties" xmlns:ns2="19037ea0-f10b-40ae-9076-89db66a894de" xmlns:ns3="08c674ba-5fce-4f45-b52a-53002431429b" targetNamespace="http://schemas.microsoft.com/office/2006/metadata/properties" ma:root="true" ma:fieldsID="32741ccdb4800b1dc5dcd9d685f98680" ns2:_="" ns3:_="">
    <xsd:import namespace="19037ea0-f10b-40ae-9076-89db66a894de"/>
    <xsd:import namespace="08c674ba-5fce-4f45-b52a-53002431429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OCR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Location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9037ea0-f10b-40ae-9076-89db66a894d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description="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f94f6455-2e7a-42ed-804e-66c7398b921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Location" ma:index="24" nillable="true" ma:displayName="Location" ma:indexed="true" ma:internalName="MediaServiceLocation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8c674ba-5fce-4f45-b52a-53002431429b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64d7f076-b0d0-40ce-a473-c236f2d5f48b}" ma:internalName="TaxCatchAll" ma:showField="CatchAllData" ma:web="08c674ba-5fce-4f45-b52a-53002431429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B79E374-0ED2-4DBF-A568-5A8D1D62EC3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1D81719-BA39-4D73-878A-4271EEAE4D7D}">
  <ds:schemaRefs>
    <ds:schemaRef ds:uri="http://schemas.microsoft.com/office/2006/metadata/properties"/>
    <ds:schemaRef ds:uri="http://schemas.microsoft.com/office/infopath/2007/PartnerControls"/>
    <ds:schemaRef ds:uri="19037ea0-f10b-40ae-9076-89db66a894de"/>
    <ds:schemaRef ds:uri="08c674ba-5fce-4f45-b52a-53002431429b"/>
  </ds:schemaRefs>
</ds:datastoreItem>
</file>

<file path=customXml/itemProps3.xml><?xml version="1.0" encoding="utf-8"?>
<ds:datastoreItem xmlns:ds="http://schemas.openxmlformats.org/officeDocument/2006/customXml" ds:itemID="{E22E1F52-6CE7-4F17-B1D5-CC492C53723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9037ea0-f10b-40ae-9076-89db66a894de"/>
    <ds:schemaRef ds:uri="08c674ba-5fce-4f45-b52a-53002431429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83</TotalTime>
  <Words>180</Words>
  <Application>Microsoft Office PowerPoint</Application>
  <PresentationFormat>Letter Paper (8.5x11 in)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jafi, Allison</dc:creator>
  <cp:lastModifiedBy>Najafi, Allison</cp:lastModifiedBy>
  <cp:revision>2</cp:revision>
  <dcterms:created xsi:type="dcterms:W3CDTF">2024-08-09T21:05:57Z</dcterms:created>
  <dcterms:modified xsi:type="dcterms:W3CDTF">2025-02-12T22:43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75E9A582350B14998924DDC17E51716</vt:lpwstr>
  </property>
  <property fmtid="{D5CDD505-2E9C-101B-9397-08002B2CF9AE}" pid="3" name="MediaServiceImageTags">
    <vt:lpwstr/>
  </property>
</Properties>
</file>